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 varScale="1">
        <p:scale>
          <a:sx n="52" d="100"/>
          <a:sy n="52" d="100"/>
        </p:scale>
        <p:origin x="1464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EC45A-EFAA-4088-A006-DE195C50F9F4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98B84-D9DA-4CAE-98C6-4EEE8103B75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44782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EC45A-EFAA-4088-A006-DE195C50F9F4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98B84-D9DA-4CAE-98C6-4EEE8103B75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67807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EC45A-EFAA-4088-A006-DE195C50F9F4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98B84-D9DA-4CAE-98C6-4EEE8103B75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32090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EC45A-EFAA-4088-A006-DE195C50F9F4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98B84-D9DA-4CAE-98C6-4EEE8103B75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65536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EC45A-EFAA-4088-A006-DE195C50F9F4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98B84-D9DA-4CAE-98C6-4EEE8103B75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81568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EC45A-EFAA-4088-A006-DE195C50F9F4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98B84-D9DA-4CAE-98C6-4EEE8103B75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7343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EC45A-EFAA-4088-A006-DE195C50F9F4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98B84-D9DA-4CAE-98C6-4EEE8103B75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48629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EC45A-EFAA-4088-A006-DE195C50F9F4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98B84-D9DA-4CAE-98C6-4EEE8103B75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07484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EC45A-EFAA-4088-A006-DE195C50F9F4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98B84-D9DA-4CAE-98C6-4EEE8103B75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77287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EC45A-EFAA-4088-A006-DE195C50F9F4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98B84-D9DA-4CAE-98C6-4EEE8103B75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2486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EC45A-EFAA-4088-A006-DE195C50F9F4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698B84-D9DA-4CAE-98C6-4EEE8103B75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92272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EC45A-EFAA-4088-A006-DE195C50F9F4}" type="datetimeFigureOut">
              <a:rPr lang="pt-BR" smtClean="0"/>
              <a:t>30/04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698B84-D9DA-4CAE-98C6-4EEE8103B75F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61931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-3491777" y="458895"/>
            <a:ext cx="19260671" cy="5334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132080" tIns="66040" rIns="132080" bIns="66040" numCol="1" anchor="ctr" anchorCtr="0" compatLnSpc="1">
            <a:prstTxWarp prst="textNoShape">
              <a:avLst/>
            </a:prstTxWarp>
            <a:spAutoFit/>
          </a:bodyPr>
          <a:lstStyle/>
          <a:p>
            <a:endParaRPr lang="pt-BR" sz="2600"/>
          </a:p>
        </p:txBody>
      </p:sp>
      <p:sp>
        <p:nvSpPr>
          <p:cNvPr id="6" name="Retângulo 5"/>
          <p:cNvSpPr/>
          <p:nvPr/>
        </p:nvSpPr>
        <p:spPr>
          <a:xfrm>
            <a:off x="0" y="8410619"/>
            <a:ext cx="6858000" cy="15664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tabLst>
                <a:tab pos="3002893" algn="l"/>
              </a:tabLst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ite contents involved in nitrogen metabolism and malate content of 4-week-old plants from two ILs of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lanum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nnellii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o a genetic background of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lanum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copersicum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M82) grown at 400 and at 800 µmol CO</a:t>
            </a:r>
            <a:r>
              <a:rPr lang="en-US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ol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Chlorophyll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/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;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mino acids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;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lat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ues are presented as means ±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 = 4). Capital letters compare means that differ between the genotypes within a treatment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 by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ke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. Lowercase letters compare means that differ in a single genotype between the two treatments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 by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ke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. FW: Fresh weight.</a:t>
            </a:r>
            <a:endParaRPr lang="pt-B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tabLst>
                <a:tab pos="3002893" algn="l"/>
              </a:tabLst>
            </a:pPr>
            <a:endParaRPr lang="pt-BR" sz="1200" dirty="0"/>
          </a:p>
        </p:txBody>
      </p:sp>
      <p:grpSp>
        <p:nvGrpSpPr>
          <p:cNvPr id="9" name="Grupo 8"/>
          <p:cNvGrpSpPr/>
          <p:nvPr/>
        </p:nvGrpSpPr>
        <p:grpSpPr>
          <a:xfrm>
            <a:off x="1291500" y="42759"/>
            <a:ext cx="4332060" cy="8367859"/>
            <a:chOff x="1382940" y="42760"/>
            <a:chExt cx="4087131" cy="8013366"/>
          </a:xfrm>
        </p:grpSpPr>
        <p:pic>
          <p:nvPicPr>
            <p:cNvPr id="7" name="Imagem 6"/>
            <p:cNvPicPr>
              <a:picLocks noChangeAspect="1"/>
            </p:cNvPicPr>
            <p:nvPr/>
          </p:nvPicPr>
          <p:blipFill rotWithShape="1">
            <a:blip r:embed="rId2"/>
            <a:srcRect r="27175"/>
            <a:stretch/>
          </p:blipFill>
          <p:spPr>
            <a:xfrm>
              <a:off x="1382940" y="42760"/>
              <a:ext cx="4087131" cy="8013366"/>
            </a:xfrm>
            <a:prstGeom prst="rect">
              <a:avLst/>
            </a:prstGeom>
          </p:spPr>
        </p:pic>
        <p:pic>
          <p:nvPicPr>
            <p:cNvPr id="8" name="Imagem 7"/>
            <p:cNvPicPr>
              <a:picLocks noChangeAspect="1"/>
            </p:cNvPicPr>
            <p:nvPr/>
          </p:nvPicPr>
          <p:blipFill rotWithShape="1">
            <a:blip r:embed="rId2"/>
            <a:srcRect l="70843" t="941" r="1296" b="93614"/>
            <a:stretch/>
          </p:blipFill>
          <p:spPr>
            <a:xfrm>
              <a:off x="3820890" y="424542"/>
              <a:ext cx="1404255" cy="39188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9869854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20</TotalTime>
  <Words>119</Words>
  <Application>Microsoft Office PowerPoint</Application>
  <PresentationFormat>Papel 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liente</dc:creator>
  <cp:lastModifiedBy>Cliente</cp:lastModifiedBy>
  <cp:revision>25</cp:revision>
  <dcterms:created xsi:type="dcterms:W3CDTF">2019-04-29T12:01:49Z</dcterms:created>
  <dcterms:modified xsi:type="dcterms:W3CDTF">2020-05-01T01:20:41Z</dcterms:modified>
</cp:coreProperties>
</file>